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7" r:id="rId2"/>
  </p:sldIdLst>
  <p:sldSz cx="9144000" cy="6858000" type="screen4x3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9" d="100"/>
          <a:sy n="109" d="100"/>
        </p:scale>
        <p:origin x="-96" y="-9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785AF-B1E1-4F34-97BE-8C145ECABD10}" type="datetimeFigureOut">
              <a:rPr lang="it-IT" smtClean="0"/>
              <a:pPr/>
              <a:t>05/03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3A87C-5636-40BC-ADDF-E76C64EF3F99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7495311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785AF-B1E1-4F34-97BE-8C145ECABD10}" type="datetimeFigureOut">
              <a:rPr lang="it-IT" smtClean="0"/>
              <a:pPr/>
              <a:t>05/03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3A87C-5636-40BC-ADDF-E76C64EF3F99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6617259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785AF-B1E1-4F34-97BE-8C145ECABD10}" type="datetimeFigureOut">
              <a:rPr lang="it-IT" smtClean="0"/>
              <a:pPr/>
              <a:t>05/03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3A87C-5636-40BC-ADDF-E76C64EF3F99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996747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785AF-B1E1-4F34-97BE-8C145ECABD10}" type="datetimeFigureOut">
              <a:rPr lang="it-IT" smtClean="0"/>
              <a:pPr/>
              <a:t>05/03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3A87C-5636-40BC-ADDF-E76C64EF3F99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367070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785AF-B1E1-4F34-97BE-8C145ECABD10}" type="datetimeFigureOut">
              <a:rPr lang="it-IT" smtClean="0"/>
              <a:pPr/>
              <a:t>05/03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3A87C-5636-40BC-ADDF-E76C64EF3F99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518596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785AF-B1E1-4F34-97BE-8C145ECABD10}" type="datetimeFigureOut">
              <a:rPr lang="it-IT" smtClean="0"/>
              <a:pPr/>
              <a:t>05/03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3A87C-5636-40BC-ADDF-E76C64EF3F99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890453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785AF-B1E1-4F34-97BE-8C145ECABD10}" type="datetimeFigureOut">
              <a:rPr lang="it-IT" smtClean="0"/>
              <a:pPr/>
              <a:t>05/03/2020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3A87C-5636-40BC-ADDF-E76C64EF3F99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471829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785AF-B1E1-4F34-97BE-8C145ECABD10}" type="datetimeFigureOut">
              <a:rPr lang="it-IT" smtClean="0"/>
              <a:pPr/>
              <a:t>05/03/2020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3A87C-5636-40BC-ADDF-E76C64EF3F99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3960986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785AF-B1E1-4F34-97BE-8C145ECABD10}" type="datetimeFigureOut">
              <a:rPr lang="it-IT" smtClean="0"/>
              <a:pPr/>
              <a:t>05/03/2020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3A87C-5636-40BC-ADDF-E76C64EF3F99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319160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785AF-B1E1-4F34-97BE-8C145ECABD10}" type="datetimeFigureOut">
              <a:rPr lang="it-IT" smtClean="0"/>
              <a:pPr/>
              <a:t>05/03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3A87C-5636-40BC-ADDF-E76C64EF3F99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44036822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D785AF-B1E1-4F34-97BE-8C145ECABD10}" type="datetimeFigureOut">
              <a:rPr lang="it-IT" smtClean="0"/>
              <a:pPr/>
              <a:t>05/03/2020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33A87C-5636-40BC-ADDF-E76C64EF3F99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2173987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D785AF-B1E1-4F34-97BE-8C145ECABD10}" type="datetimeFigureOut">
              <a:rPr lang="it-IT" smtClean="0"/>
              <a:pPr/>
              <a:t>05/03/2020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33A87C-5636-40BC-ADDF-E76C64EF3F99}" type="slidenum">
              <a:rPr lang="it-IT" smtClean="0"/>
              <a:pPr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670749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>
            <a:extLst>
              <a:ext uri="{FF2B5EF4-FFF2-40B4-BE49-F238E27FC236}">
                <a16:creationId xmlns="" xmlns:a16="http://schemas.microsoft.com/office/drawing/2014/main" id="{2985F4A5-5E9A-4096-A408-CDD05DC3B217}"/>
              </a:ext>
            </a:extLst>
          </p:cNvPr>
          <p:cNvGrpSpPr/>
          <p:nvPr/>
        </p:nvGrpSpPr>
        <p:grpSpPr>
          <a:xfrm>
            <a:off x="1264511" y="244657"/>
            <a:ext cx="5953125" cy="5010150"/>
            <a:chOff x="0" y="0"/>
            <a:chExt cx="5953125" cy="5010150"/>
          </a:xfrm>
        </p:grpSpPr>
        <p:pic>
          <p:nvPicPr>
            <p:cNvPr id="3" name="Picture 3"/>
            <p:cNvPicPr>
              <a:picLocks noChangeAspect="1" noChangeArrowheads="1"/>
            </p:cNvPicPr>
            <p:nvPr/>
          </p:nvPicPr>
          <p:blipFill>
            <a:blip r:embed="rId2" cstate="print"/>
            <a:srcRect/>
            <a:stretch>
              <a:fillRect/>
            </a:stretch>
          </p:blipFill>
          <p:spPr bwMode="auto">
            <a:xfrm>
              <a:off x="0" y="0"/>
              <a:ext cx="5953125" cy="5010150"/>
            </a:xfrm>
            <a:prstGeom prst="rect">
              <a:avLst/>
            </a:prstGeom>
            <a:noFill/>
            <a:ln w="9525">
              <a:solidFill>
                <a:schemeClr val="accent1"/>
              </a:solidFill>
              <a:miter lim="800000"/>
              <a:headEnd/>
              <a:tailEnd/>
            </a:ln>
            <a:effectLst/>
          </p:spPr>
        </p:pic>
        <p:sp>
          <p:nvSpPr>
            <p:cNvPr id="4" name="CasellaDiTesto 5"/>
            <p:cNvSpPr txBox="1"/>
            <p:nvPr/>
          </p:nvSpPr>
          <p:spPr>
            <a:xfrm>
              <a:off x="4669833" y="0"/>
              <a:ext cx="1214755" cy="4273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it-IT" sz="1400" kern="1200">
                  <a:solidFill>
                    <a:srgbClr val="00000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P&lt;0.0001</a:t>
              </a:r>
              <a:endParaRPr lang="it-IT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5" name="CasellaDiTesto 6"/>
            <p:cNvSpPr txBox="1"/>
            <p:nvPr/>
          </p:nvSpPr>
          <p:spPr>
            <a:xfrm>
              <a:off x="1641439" y="800078"/>
              <a:ext cx="2785745" cy="4273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it-IT" sz="1400" b="1" kern="1200">
                  <a:solidFill>
                    <a:srgbClr val="0070C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dNLR &lt; 3</a:t>
              </a:r>
              <a:endParaRPr lang="it-IT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  <p:sp>
          <p:nvSpPr>
            <p:cNvPr id="6" name="CasellaDiTesto 7"/>
            <p:cNvSpPr txBox="1"/>
            <p:nvPr/>
          </p:nvSpPr>
          <p:spPr>
            <a:xfrm>
              <a:off x="2748728" y="3605163"/>
              <a:ext cx="2785745" cy="4273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>
                <a:lnSpc>
                  <a:spcPct val="107000"/>
                </a:lnSpc>
                <a:spcAft>
                  <a:spcPts val="800"/>
                </a:spcAft>
              </a:pPr>
              <a:r>
                <a:rPr lang="it-IT" sz="1400" b="1" kern="1200">
                  <a:solidFill>
                    <a:srgbClr val="00B050"/>
                  </a:solidFill>
                  <a:effectLst/>
                  <a:latin typeface="Calibri" panose="020F050202020403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dNLR &gt; 3</a:t>
              </a:r>
              <a:endParaRPr lang="it-IT" sz="1100">
                <a:effectLst/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endParaRPr>
            </a:p>
          </p:txBody>
        </p:sp>
      </p:grpSp>
      <p:sp>
        <p:nvSpPr>
          <p:cNvPr id="7" name="Rettangolo 6"/>
          <p:cNvSpPr/>
          <p:nvPr/>
        </p:nvSpPr>
        <p:spPr>
          <a:xfrm>
            <a:off x="907454" y="5445039"/>
            <a:ext cx="7034758" cy="88280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. S2</a:t>
            </a:r>
            <a:r>
              <a:rPr lang="en-US" sz="1200" b="1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r>
              <a:rPr lang="en-US" sz="120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Kaplan-Meier 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S curves of melanoma patient treated with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ivolumab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, according to the baseline derived neutrophils-to lymphocyte ratio (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NLR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). Green line: dNLR≥3; Blue line: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NLR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lt;3. Patients with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NLR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lt;3 had a median OS of 19.2 ( 95% CI: 12.4-26.0) months respect to patients with </a:t>
            </a:r>
            <a:r>
              <a:rPr lang="en-US" sz="1200" dirty="0" err="1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NLR</a:t>
            </a:r>
            <a:r>
              <a:rPr lang="en-US" sz="1200" dirty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&gt;3 with a median OS of 2.9  (P&lt;0.0001). </a:t>
            </a:r>
            <a:endParaRPr lang="it-IT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8112973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</TotalTime>
  <Words>75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Tema di Offic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orello.silvana@gmail.com</dc:creator>
  <cp:lastModifiedBy>Shine David S.A.</cp:lastModifiedBy>
  <cp:revision>7</cp:revision>
  <dcterms:created xsi:type="dcterms:W3CDTF">2019-09-10T11:38:44Z</dcterms:created>
  <dcterms:modified xsi:type="dcterms:W3CDTF">2020-03-05T07:27:02Z</dcterms:modified>
</cp:coreProperties>
</file>